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26" autoAdjust="0"/>
    <p:restoredTop sz="94660"/>
  </p:normalViewPr>
  <p:slideViewPr>
    <p:cSldViewPr>
      <p:cViewPr varScale="1">
        <p:scale>
          <a:sx n="87" d="100"/>
          <a:sy n="87" d="100"/>
        </p:scale>
        <p:origin x="1488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141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43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825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398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49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437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940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102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128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19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922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CF328-BC62-439D-917C-EB2EDD92DE30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45899-7640-4896-AB7C-7986933F9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706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microsoft.com/office/2007/relationships/hdphoto" Target="../media/hdphoto1.wdp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2400" y="76200"/>
            <a:ext cx="8839200" cy="6629400"/>
          </a:xfrm>
        </p:spPr>
        <p:txBody>
          <a:bodyPr/>
          <a:lstStyle/>
          <a:p>
            <a:pPr marL="0" indent="0">
              <a:buNone/>
            </a:pPr>
            <a:endParaRPr lang="en-US" dirty="0" smtClean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 smtClean="0"/>
          </a:p>
          <a:p>
            <a:pPr marL="0" indent="0">
              <a:buNone/>
            </a:pPr>
            <a:r>
              <a:rPr lang="en-US" dirty="0" smtClean="0"/>
              <a:t>                       </a:t>
            </a:r>
          </a:p>
          <a:p>
            <a:pPr marL="0" indent="0">
              <a:buNone/>
            </a:pP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sz="2000" b="1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895600" y="2209800"/>
            <a:ext cx="4038600" cy="13716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RIGINAL WESTERN BLOT </a:t>
            </a:r>
            <a:endParaRPr lang="en-US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30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24200" y="228600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Cortex</a:t>
            </a:r>
            <a:r>
              <a:rPr lang="en-US" sz="1000" u="sng" dirty="0" smtClean="0"/>
              <a:t>    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4572000" y="228600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r>
              <a:rPr lang="en-US" sz="1000" u="sng" dirty="0" smtClean="0"/>
              <a:t>  </a:t>
            </a:r>
            <a:endParaRPr lang="en-US" sz="1000" u="sng" dirty="0"/>
          </a:p>
        </p:txBody>
      </p:sp>
      <p:pic>
        <p:nvPicPr>
          <p:cNvPr id="1026" name="Picture 2" descr="C:\Users\USER\Desktop\original western blot\original western blots - Copy\TLR4 cortex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406" y="533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USER\Desktop\original western blot\original western blots - Copy (2)\TLR4 hippo (2)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825" y="533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USER\Desktop\original western blot\original western blots - Copy\Gfap.jpg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406" y="15240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USER\Desktop\original western blot\original western blots - Copy\Iba-1.jpg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406" y="25146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USER\Desktop\original western blot\original western blots - Copy\NfkB.jp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406" y="35052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USER\Desktop\original western blot\original western blots - Copy (2)\Gfap.jp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825" y="15240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USER\Desktop\original western blot\original western blots - Copy (2)\Iba-1.jpg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825" y="25146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USER\Desktop\original western blot\original western blots - Copy (2)\NfkB.jp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825" y="35052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" name="Straight Arrow Connector 7"/>
          <p:cNvCxnSpPr/>
          <p:nvPr/>
        </p:nvCxnSpPr>
        <p:spPr>
          <a:xfrm>
            <a:off x="2335244" y="801715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2322661" y="1849682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2347466" y="2847939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2335244" y="3733800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2338449" y="5019138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411444" y="569019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TLR4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349978" y="1616986"/>
            <a:ext cx="533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GFAP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315041" y="3510163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800" b="1" dirty="0" err="1" smtClean="0">
                <a:latin typeface="Times New Roman" pitchFamily="18" charset="0"/>
                <a:cs typeface="Times New Roman" pitchFamily="18" charset="0"/>
              </a:rPr>
              <a:t>NFkB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362200" y="2603956"/>
            <a:ext cx="533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Iba-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338449" y="4786441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p-JNK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588527" y="381000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588527" y="685800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95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88527" y="1752600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50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88527" y="2680156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17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588527" y="3518356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65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588527" y="4953000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56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C:\Users\USER\Desktop\original western blots\New folder - Copy\actin-1.jpg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406" y="5562601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 descr="C:\Users\USER\Desktop\original western blots\New folder - Copy (2)\actin-1.jpg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694" y="55626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6" name="Straight Arrow Connector 35"/>
          <p:cNvCxnSpPr/>
          <p:nvPr/>
        </p:nvCxnSpPr>
        <p:spPr>
          <a:xfrm>
            <a:off x="2352250" y="6097115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2352250" y="5864418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-actin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588527" y="5956756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43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434931" y="88761"/>
            <a:ext cx="9220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2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4" descr="C:\Users\USER\Desktop\original western blots\New folder\img437.jpg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4456" y="45720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5" descr="C:\Users\USER\Desktop\original western blots\New folder - Copy (2)\img437.jpg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2960" y="45720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9847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8600" y="152400"/>
            <a:ext cx="8686800" cy="6553200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 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91840" y="1295400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Cortex</a:t>
            </a:r>
            <a:r>
              <a:rPr lang="en-US" sz="1000" u="sng" dirty="0" smtClean="0"/>
              <a:t>    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4739640" y="1295400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r>
              <a:rPr lang="en-US" sz="1000" u="sng" dirty="0" smtClean="0"/>
              <a:t>  </a:t>
            </a:r>
            <a:endParaRPr lang="en-US" sz="1000" u="sng" dirty="0"/>
          </a:p>
        </p:txBody>
      </p:sp>
      <p:pic>
        <p:nvPicPr>
          <p:cNvPr id="2050" name="Picture 2" descr="C:\Users\USER\Desktop\original western blot\original western blots - Copy\Tnf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440" y="1676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USER\Desktop\original western blot\original western blots - Copy (2)\Tnf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676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USER\Desktop\original western blot\original western blots - Copy\IL-1B cortex.jp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440" y="2819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USER\Desktop\original western blot\original western blots - Copy (2)\IL-1B.jpg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9640" y="2819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" name="Straight Arrow Connector 10"/>
          <p:cNvCxnSpPr/>
          <p:nvPr/>
        </p:nvCxnSpPr>
        <p:spPr>
          <a:xfrm>
            <a:off x="2529840" y="2331720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2512867" y="3168878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512867" y="2111953"/>
            <a:ext cx="6740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TNF-</a:t>
            </a:r>
            <a:r>
              <a:rPr lang="el-GR" sz="1000" b="1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506980" y="2953434"/>
            <a:ext cx="621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  IL-1</a:t>
            </a:r>
            <a:r>
              <a:rPr lang="el-GR" sz="800" b="1" dirty="0">
                <a:latin typeface="Times New Roman" pitchFamily="18" charset="0"/>
                <a:cs typeface="Times New Roman" pitchFamily="18" charset="0"/>
              </a:rPr>
              <a:t>β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723053" y="1610651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23648" y="2209800"/>
            <a:ext cx="4479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17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707813" y="3061156"/>
            <a:ext cx="4796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3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C:\Users\USER\Desktop\original western blots\New folder - Copy\actin-2.jpg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440" y="4038599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USER\Desktop\original western blots\New folder - Copy (2)\actin-2.jp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9640" y="4038599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Straight Arrow Connector 19"/>
          <p:cNvCxnSpPr/>
          <p:nvPr/>
        </p:nvCxnSpPr>
        <p:spPr>
          <a:xfrm>
            <a:off x="2506980" y="4540478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501093" y="4335259"/>
            <a:ext cx="621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sz="1000" b="1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-actin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707813" y="4432756"/>
            <a:ext cx="4796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43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899805" y="960120"/>
            <a:ext cx="9220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3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65980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4800" y="228600"/>
            <a:ext cx="8610600" cy="6477000"/>
          </a:xfrm>
        </p:spPr>
        <p:txBody>
          <a:bodyPr/>
          <a:lstStyle/>
          <a:p>
            <a:pPr marL="0" indent="0">
              <a:buNone/>
            </a:pP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505200" y="1354348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Cortex</a:t>
            </a:r>
            <a:r>
              <a:rPr lang="en-US" sz="1000" u="sng" dirty="0" smtClean="0"/>
              <a:t>    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4953000" y="1354348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r>
              <a:rPr lang="en-US" sz="1000" u="sng" dirty="0" smtClean="0"/>
              <a:t>  </a:t>
            </a:r>
            <a:endParaRPr lang="en-US" sz="1000" u="sng" dirty="0"/>
          </a:p>
        </p:txBody>
      </p:sp>
      <p:pic>
        <p:nvPicPr>
          <p:cNvPr id="3074" name="Picture 2" descr="C:\Users\USER\Desktop\original western blot\original western blots - Copy\HO-1 cortex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5548" y="2878348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USER\Desktop\original western blot\original western blots - Copy\Nrf2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7560" y="1753954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USER\Desktop\original western blot\original western blots - Copy (2)\HO-1.jp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878348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USER\Desktop\original western blot\original western blots - Copy (2)\Nrf2.jpg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7526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" name="Straight Arrow Connector 9"/>
          <p:cNvCxnSpPr/>
          <p:nvPr/>
        </p:nvCxnSpPr>
        <p:spPr>
          <a:xfrm>
            <a:off x="2725948" y="2030686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2699664" y="3511199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758095" y="1798392"/>
            <a:ext cx="5493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Nrf2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23464" y="3264978"/>
            <a:ext cx="589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HO-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885548" y="1675028"/>
            <a:ext cx="51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943238" y="1890472"/>
            <a:ext cx="3998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68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989209" y="3455292"/>
            <a:ext cx="307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34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C:\Users\USER\Desktop\original western blots\New folder - Copy\actin-3.jpg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4097548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USER\Desktop\original western blots\New folder - Copy (2)\actin-3.jp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4097548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Straight Arrow Connector 17"/>
          <p:cNvCxnSpPr/>
          <p:nvPr/>
        </p:nvCxnSpPr>
        <p:spPr>
          <a:xfrm>
            <a:off x="2724708" y="4614814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648508" y="4368593"/>
            <a:ext cx="589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sz="1000" b="1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-actin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89209" y="4491704"/>
            <a:ext cx="307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43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19895" y="973347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4B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042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52400"/>
            <a:ext cx="8382000" cy="6553200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 </a:t>
            </a:r>
          </a:p>
        </p:txBody>
      </p:sp>
      <p:pic>
        <p:nvPicPr>
          <p:cNvPr id="4098" name="Picture 2" descr="C:\Users\USER\Desktop\original western blot\original western blots - Copy\snap-23.jp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3983" y="2819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USER\Desktop\original western blot\original western blots - Copy\psd-95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3983" y="16002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474720" y="1219200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Cortex</a:t>
            </a:r>
            <a:r>
              <a:rPr lang="en-US" sz="1000" u="sng" dirty="0" smtClean="0"/>
              <a:t>    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4922520" y="1219200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r>
              <a:rPr lang="en-US" sz="1000" u="sng" dirty="0" smtClean="0"/>
              <a:t>  </a:t>
            </a:r>
            <a:endParaRPr lang="en-US" sz="1000" u="sng" dirty="0"/>
          </a:p>
        </p:txBody>
      </p:sp>
      <p:pic>
        <p:nvPicPr>
          <p:cNvPr id="4100" name="Picture 4" descr="C:\Users\USER\Desktop\original western blot\original western blots - Copy (2)\snap-23.jp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8194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USER\Desktop\original western blot\original western blots - Copy (2)\psd-95.jpg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6002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" name="Straight Arrow Connector 9"/>
          <p:cNvCxnSpPr/>
          <p:nvPr/>
        </p:nvCxnSpPr>
        <p:spPr>
          <a:xfrm>
            <a:off x="2696046" y="1866984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2648294" y="3492571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871694" y="1548343"/>
            <a:ext cx="51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800" dirty="0" smtClean="0"/>
              <a:t> 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94014" y="1673093"/>
            <a:ext cx="674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PSD-95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644833" y="3273293"/>
            <a:ext cx="849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SNAP-23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976473" y="1752600"/>
            <a:ext cx="305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95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950830" y="3367686"/>
            <a:ext cx="356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23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C:\Users\USER\Desktop\original western blots\New folder - Copy\actin-4.jpg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3983" y="41148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USER\Desktop\original western blots\New folder - Copy (2)\actin-4.jp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4114800"/>
            <a:ext cx="1005840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Straight Arrow Connector 17"/>
          <p:cNvCxnSpPr/>
          <p:nvPr/>
        </p:nvCxnSpPr>
        <p:spPr>
          <a:xfrm>
            <a:off x="2683362" y="4676014"/>
            <a:ext cx="6096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736319" y="4456735"/>
            <a:ext cx="5277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-actin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75355" y="4523612"/>
            <a:ext cx="307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43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39584" y="965489"/>
            <a:ext cx="9220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5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4607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94</TotalTime>
  <Words>69</Words>
  <Application>Microsoft Office PowerPoint</Application>
  <PresentationFormat>On-screen Show (4:3)</PresentationFormat>
  <Paragraphs>5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ismail - [2010]</cp:lastModifiedBy>
  <cp:revision>34</cp:revision>
  <dcterms:created xsi:type="dcterms:W3CDTF">2024-08-27T07:41:39Z</dcterms:created>
  <dcterms:modified xsi:type="dcterms:W3CDTF">2024-09-21T08:06:11Z</dcterms:modified>
</cp:coreProperties>
</file>